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2" r:id="rId2"/>
    <p:sldId id="302" r:id="rId3"/>
    <p:sldId id="297" r:id="rId4"/>
    <p:sldId id="298" r:id="rId5"/>
    <p:sldId id="299" r:id="rId6"/>
    <p:sldId id="300" r:id="rId7"/>
    <p:sldId id="301" r:id="rId8"/>
    <p:sldId id="281" r:id="rId9"/>
    <p:sldId id="293" r:id="rId10"/>
    <p:sldId id="282" r:id="rId11"/>
    <p:sldId id="278" r:id="rId12"/>
    <p:sldId id="277" r:id="rId13"/>
    <p:sldId id="294" r:id="rId14"/>
    <p:sldId id="288" r:id="rId1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6395" autoAdjust="0"/>
  </p:normalViewPr>
  <p:slideViewPr>
    <p:cSldViewPr snapToGrid="0">
      <p:cViewPr varScale="1">
        <p:scale>
          <a:sx n="73" d="100"/>
          <a:sy n="73" d="100"/>
        </p:scale>
        <p:origin x="80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image" Target="../media/image38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5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879369-EC04-4E9F-8439-49129426BC3B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6162F5-D60D-4A85-A804-5287B117F7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383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6162F5-D60D-4A85-A804-5287B117F71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2036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57378-D82E-483F-B0E6-EE68CAD9FA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4DEA3C-7919-4B89-904B-45916D0957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14810-7722-4E63-B466-EA5E10DF3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71042-0B3B-4253-9043-AEEFD9F85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58278C-255F-4C9C-96E4-3AA0E664B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41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3095F9-AC7E-45FF-B64D-8244AA9D39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9C61C4-6C25-4A94-927F-E242AA691F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F131D-B66C-4B2B-BED4-EB5F72393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C0A85-E08E-45D4-9152-DAF91BF78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0DD651-785F-49E4-A356-4A44A53AE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094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1F486C-EDE0-4716-ACAC-161975A0D3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5BDC55-7ED2-40F6-82AA-3292EA1851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B9096D-42CF-4CC1-BB3E-FC8847E58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ACACA4-501F-4DFF-9C53-4533E19D3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14A79B-2DC1-4850-8470-DF23D2839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159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8B7F8C-983D-4EA3-ACAB-7D9D12749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1A51D6-A04B-4946-9447-7AD9235CED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E6CDD-7209-41BE-8771-F21BCEEF0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08F5CA-44F5-47DD-87C7-AE99FC9B8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B815A3-80BE-4462-B269-BEFD5CD16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505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0BFFA-FCF7-4BA7-9658-63A03E8E52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89F99C-C18D-4A35-B7C8-871B3A2A35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82B2D-E825-426E-92BD-B9AE4F0D6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562274-A860-46FE-AA70-134E61D03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71FAA-6C2C-4E0C-B759-32FF2D853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47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ADD32-174D-4FC3-9690-2791A6A5D8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A0758F-6A87-470C-9913-944B751443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443C55-1C66-49D0-A26A-853AF4A7F8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7D3039-02DC-4750-A0DC-1EE6F01F3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9434CE-26AD-4D41-92F8-D18B6B688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39D022-EC73-4DA0-BB89-3096E52A9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581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CC630-DD50-4178-AC3D-AD4F3CBE8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81748C-4B91-4B39-B8D5-95CDC0A90B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1BF547-39DF-4D49-A3E6-B2243DF907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72BA6F-9836-4C79-9C94-30850E91E8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2EC70D-FDC1-46BB-9A66-688B747236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166A02-E68A-4460-8D34-29A348977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4D09A2-197C-4973-AB54-FD026C5A8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5A2BF0-810D-47F8-8BED-F69DCC1E2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501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D7153-B502-4BA8-A9FC-379E1908A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1788AB-AC83-45FC-ABFE-38F04506B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930F8D-4822-402C-92CD-880FB9DF8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AFF306-191F-4600-837A-D49A84D39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294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4FE042-B8EF-463A-86CA-545FE520E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B777AD-20D1-4173-B8FD-33C0AC8AA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6D2FD8-C97B-4747-930C-7CBDDAAAC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265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582F2C-150C-4411-9BC2-D043355DB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A8BDC-1E79-4D35-8C37-F5FD3732A2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2D3AAF-EF21-486D-BA11-794966F32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46930B-7C14-4AFE-AAAF-4389E0FAA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167F05-B95A-490C-8483-8EE2551FE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3445D3-D69F-42D8-980B-12BA21450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354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F7849-3B9E-445C-9F97-A12D45034E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50F8AB4-0705-471C-8AD8-1C4FA7D0AE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F1C4DC-CAE1-4635-97B9-EE097E3332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B1ECC9-49C1-449D-A7B1-ED0059AA3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5A3A69-2D93-41A8-AA01-17225994D1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516EB0-0347-4C82-8F2D-5CE1815A3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91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97A021-C56A-46C7-9815-492E30B17B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08BAC2-77FE-4B02-8761-F11CCC3558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8B920C-AC85-4192-B57E-7CBEFCE795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0D758-A3AB-4DBC-9175-12F749D07061}" type="datetimeFigureOut">
              <a:rPr lang="en-US" smtClean="0"/>
              <a:t>2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0B2FA4-BD34-4AE7-B182-5A352C1532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FD7F1-0793-454E-BA35-B3B58A6BB3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C50DE-36D2-4739-B8CA-437AA5054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9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8.emf"/><Relationship Id="rId4" Type="http://schemas.openxmlformats.org/officeDocument/2006/relationships/image" Target="../media/image5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59.emf"/><Relationship Id="rId4" Type="http://schemas.openxmlformats.org/officeDocument/2006/relationships/oleObject" Target="../embeddings/oleObject23.bin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e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emf"/><Relationship Id="rId9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5" Type="http://schemas.openxmlformats.org/officeDocument/2006/relationships/image" Target="../media/image7.emf"/><Relationship Id="rId10" Type="http://schemas.openxmlformats.org/officeDocument/2006/relationships/image" Target="../media/image13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19.emf"/><Relationship Id="rId17" Type="http://schemas.openxmlformats.org/officeDocument/2006/relationships/image" Target="../media/image21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9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image" Target="../media/image22.emf"/><Relationship Id="rId10" Type="http://schemas.openxmlformats.org/officeDocument/2006/relationships/image" Target="../media/image18.e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13" Type="http://schemas.openxmlformats.org/officeDocument/2006/relationships/image" Target="../media/image26.emf"/><Relationship Id="rId3" Type="http://schemas.openxmlformats.org/officeDocument/2006/relationships/oleObject" Target="../embeddings/oleObject10.bin"/><Relationship Id="rId7" Type="http://schemas.openxmlformats.org/officeDocument/2006/relationships/image" Target="../media/image28.emf"/><Relationship Id="rId12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4.emf"/><Relationship Id="rId11" Type="http://schemas.openxmlformats.org/officeDocument/2006/relationships/image" Target="../media/image25.emf"/><Relationship Id="rId5" Type="http://schemas.openxmlformats.org/officeDocument/2006/relationships/oleObject" Target="../embeddings/oleObject11.bin"/><Relationship Id="rId15" Type="http://schemas.openxmlformats.org/officeDocument/2006/relationships/image" Target="../media/image27.emf"/><Relationship Id="rId10" Type="http://schemas.openxmlformats.org/officeDocument/2006/relationships/oleObject" Target="../embeddings/oleObject12.bin"/><Relationship Id="rId4" Type="http://schemas.openxmlformats.org/officeDocument/2006/relationships/image" Target="../media/image23.emf"/><Relationship Id="rId9" Type="http://schemas.openxmlformats.org/officeDocument/2006/relationships/image" Target="../media/image30.emf"/><Relationship Id="rId14" Type="http://schemas.openxmlformats.org/officeDocument/2006/relationships/oleObject" Target="../embeddings/oleObject1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13" Type="http://schemas.openxmlformats.org/officeDocument/2006/relationships/image" Target="../media/image37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32.e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5" Type="http://schemas.openxmlformats.org/officeDocument/2006/relationships/image" Target="../media/image36.emf"/><Relationship Id="rId10" Type="http://schemas.openxmlformats.org/officeDocument/2006/relationships/image" Target="../media/image34.emf"/><Relationship Id="rId4" Type="http://schemas.openxmlformats.org/officeDocument/2006/relationships/image" Target="../media/image31.emf"/><Relationship Id="rId9" Type="http://schemas.openxmlformats.org/officeDocument/2006/relationships/oleObject" Target="../embeddings/oleObject18.bin"/><Relationship Id="rId14" Type="http://schemas.openxmlformats.org/officeDocument/2006/relationships/oleObject" Target="../embeddings/oleObject20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3" Type="http://schemas.openxmlformats.org/officeDocument/2006/relationships/oleObject" Target="../embeddings/oleObject21.bin"/><Relationship Id="rId7" Type="http://schemas.openxmlformats.org/officeDocument/2006/relationships/oleObject" Target="../embeddings/oleObject2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8.emf"/><Relationship Id="rId9" Type="http://schemas.openxmlformats.org/officeDocument/2006/relationships/image" Target="../media/image42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emf"/><Relationship Id="rId3" Type="http://schemas.openxmlformats.org/officeDocument/2006/relationships/image" Target="../media/image44.emf"/><Relationship Id="rId7" Type="http://schemas.openxmlformats.org/officeDocument/2006/relationships/image" Target="../media/image48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10" Type="http://schemas.openxmlformats.org/officeDocument/2006/relationships/image" Target="../media/image51.png"/><Relationship Id="rId4" Type="http://schemas.openxmlformats.org/officeDocument/2006/relationships/image" Target="../media/image45.emf"/><Relationship Id="rId9" Type="http://schemas.openxmlformats.org/officeDocument/2006/relationships/image" Target="../media/image5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3647EEE-6679-4034-8D3A-0F64E321F5E7}"/>
              </a:ext>
            </a:extLst>
          </p:cNvPr>
          <p:cNvSpPr txBox="1"/>
          <p:nvPr/>
        </p:nvSpPr>
        <p:spPr>
          <a:xfrm>
            <a:off x="151922" y="2047418"/>
            <a:ext cx="1190105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</a:t>
            </a:r>
            <a:r>
              <a:rPr lang="en-IN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: </a:t>
            </a:r>
            <a:r>
              <a:rPr lang="en-IN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edicted </a:t>
            </a:r>
            <a:r>
              <a:rPr lang="en-IN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p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cDrugs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ynergize with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xazomib (</a:t>
            </a:r>
            <a:r>
              <a:rPr lang="en-US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cDrug+IXA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in myeloma cell lines representing innate sensitive, Innate resistance, Parental/sensitive and clonally-derived acquired PI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istance.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K866;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PF.4708671;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X4720;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M201636;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)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avitoclax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) MLN4924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viability was assessed by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Titer-Glo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say (48h). </a:t>
            </a:r>
            <a:r>
              <a:rPr lang="en-US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 – Combination index calculated using Chou-Talalay’s CI theorem)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CI&gt;1 – antagonism; CI=1 – additive; CI&lt;1 – synergism) (VR-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lcade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rtezomib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PI-resistant cell lines).</a:t>
            </a:r>
          </a:p>
          <a:p>
            <a:pPr algn="just"/>
            <a:endParaRPr lang="en-US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33979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FF8141B-1C10-45DB-996A-693F860446E5}"/>
              </a:ext>
            </a:extLst>
          </p:cNvPr>
          <p:cNvSpPr txBox="1"/>
          <p:nvPr/>
        </p:nvSpPr>
        <p:spPr>
          <a:xfrm>
            <a:off x="0" y="0"/>
            <a:ext cx="12192000" cy="6701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: Comparison of Ixazomib dose-response curves and Ixa-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lues following HSP90 inhibition, either through 17-AAG treatment or CRISPR-mediated HSP90 knockdown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827657D-99F2-4902-A58E-DC9E258A0A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49" r="6612"/>
          <a:stretch/>
        </p:blipFill>
        <p:spPr>
          <a:xfrm>
            <a:off x="3776133" y="918301"/>
            <a:ext cx="4639733" cy="19037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D11B3D30-FEF6-41EC-8215-8C5F01DEC3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100" y="3286507"/>
            <a:ext cx="4639733" cy="218078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1B6E3E4-2F04-4DDB-916E-CF81C2B1129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8079"/>
          <a:stretch/>
        </p:blipFill>
        <p:spPr>
          <a:xfrm>
            <a:off x="9470316" y="2595154"/>
            <a:ext cx="2535584" cy="35822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5B5EB25-65CD-4FEA-ABB8-220135B0EA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51507" y="3286507"/>
            <a:ext cx="4279752" cy="218078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2158130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08E076E-418F-44AC-921E-BA5CD4116976}"/>
              </a:ext>
            </a:extLst>
          </p:cNvPr>
          <p:cNvSpPr txBox="1"/>
          <p:nvPr/>
        </p:nvSpPr>
        <p:spPr>
          <a:xfrm>
            <a:off x="0" y="16378"/>
            <a:ext cx="12192000" cy="6701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: Comparison of dose-response curves of PI-sensitive, PI-resistant and </a:t>
            </a:r>
            <a:r>
              <a:rPr lang="en-US" sz="18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Ras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utant HMCLs following 17-AAG treatmen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4DFA71-CCEF-454B-9400-EACFF96ECA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79" y="1781000"/>
            <a:ext cx="8488219" cy="4150832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1F5EBF4-E5FE-45A0-969A-BBD6B4B196E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44170" y="1780999"/>
          <a:ext cx="3460471" cy="4150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9" r:id="rId4" imgW="2538758" imgH="3044555" progId="Prism9.Document">
                  <p:embed/>
                </p:oleObj>
              </mc:Choice>
              <mc:Fallback>
                <p:oleObj name="Prism 9" r:id="rId4" imgW="2538758" imgH="3044555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1F5EBF4-E5FE-45A0-969A-BBD6B4B196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44170" y="1780999"/>
                        <a:ext cx="3460471" cy="415083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467707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D53E964B-AD91-48C8-9F9B-4FADCA2716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87" b="4803"/>
          <a:stretch/>
        </p:blipFill>
        <p:spPr>
          <a:xfrm>
            <a:off x="6396942" y="2003218"/>
            <a:ext cx="5795058" cy="35630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980F6A0-E425-457E-8B19-912D63074DAB}"/>
              </a:ext>
            </a:extLst>
          </p:cNvPr>
          <p:cNvSpPr txBox="1"/>
          <p:nvPr/>
        </p:nvSpPr>
        <p:spPr>
          <a:xfrm>
            <a:off x="0" y="21671"/>
            <a:ext cx="12192000" cy="9814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6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nn diagram </a:t>
            </a:r>
            <a:r>
              <a:rPr lang="en-US" sz="18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PA analysis results </a:t>
            </a:r>
            <a:r>
              <a:rPr lang="en-US" sz="1800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ing differentially expressed genes from comparison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single-agent 17-AAG-induced kinetic changes (Treated vs Untreated signatures) when each cell line (RPMI8226, FLAM76, JIM3, U266 and LP1) were considered separately (|fold-change|&gt;2; p&lt;0.05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689E94F-66B0-46EF-ADD0-385C90745F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686" y="988154"/>
            <a:ext cx="6547406" cy="5784601"/>
          </a:xfrm>
          <a:prstGeom prst="rect">
            <a:avLst/>
          </a:prstGeom>
        </p:spPr>
      </p:pic>
      <p:sp>
        <p:nvSpPr>
          <p:cNvPr id="5" name="Arrow: Right 4">
            <a:extLst>
              <a:ext uri="{FF2B5EF4-FFF2-40B4-BE49-F238E27FC236}">
                <a16:creationId xmlns:a16="http://schemas.microsoft.com/office/drawing/2014/main" id="{126D8D68-CF40-4B56-A5E5-EB16F777902E}"/>
              </a:ext>
            </a:extLst>
          </p:cNvPr>
          <p:cNvSpPr/>
          <p:nvPr/>
        </p:nvSpPr>
        <p:spPr>
          <a:xfrm>
            <a:off x="3841642" y="3625485"/>
            <a:ext cx="3155431" cy="318541"/>
          </a:xfrm>
          <a:prstGeom prst="rightArrow">
            <a:avLst/>
          </a:prstGeom>
          <a:gradFill flip="none" rotWithShape="1">
            <a:gsLst>
              <a:gs pos="0">
                <a:schemeClr val="accent2">
                  <a:lumMod val="67000"/>
                </a:schemeClr>
              </a:gs>
              <a:gs pos="48000">
                <a:schemeClr val="accent2">
                  <a:lumMod val="97000"/>
                  <a:lumOff val="3000"/>
                </a:schemeClr>
              </a:gs>
              <a:gs pos="100000">
                <a:schemeClr val="accent2">
                  <a:lumMod val="60000"/>
                  <a:lumOff val="40000"/>
                </a:schemeClr>
              </a:gs>
            </a:gsLst>
            <a:lin ang="16200000" scaled="1"/>
            <a:tileRect/>
          </a:gra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00D75A5-B4EF-4BC9-A052-28DB18688BB6}"/>
              </a:ext>
            </a:extLst>
          </p:cNvPr>
          <p:cNvSpPr txBox="1"/>
          <p:nvPr/>
        </p:nvSpPr>
        <p:spPr>
          <a:xfrm>
            <a:off x="7435" y="3880454"/>
            <a:ext cx="88977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/>
              <a:t>RPMI8226</a:t>
            </a:r>
          </a:p>
        </p:txBody>
      </p:sp>
    </p:spTree>
    <p:extLst>
      <p:ext uri="{BB962C8B-B14F-4D97-AF65-F5344CB8AC3E}">
        <p14:creationId xmlns:p14="http://schemas.microsoft.com/office/powerpoint/2010/main" val="48609711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venn diagram&#10;&#10;Description automatically generated">
            <a:extLst>
              <a:ext uri="{FF2B5EF4-FFF2-40B4-BE49-F238E27FC236}">
                <a16:creationId xmlns:a16="http://schemas.microsoft.com/office/drawing/2014/main" id="{A11FB954-D9C9-43A6-96B7-0B62F55019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26" r="24140" b="14055"/>
          <a:stretch/>
        </p:blipFill>
        <p:spPr>
          <a:xfrm>
            <a:off x="321679" y="915529"/>
            <a:ext cx="7136534" cy="502694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5DEE702-05FE-4BAA-BA3E-7CF90A926288}"/>
              </a:ext>
            </a:extLst>
          </p:cNvPr>
          <p:cNvSpPr txBox="1"/>
          <p:nvPr/>
        </p:nvSpPr>
        <p:spPr>
          <a:xfrm>
            <a:off x="0" y="0"/>
            <a:ext cx="12192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7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Ven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iagram showing genes that we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p&lt;0.05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 either 17-AAG vs CON, IXA vs CON and/or 17-AAG+IXA vs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Inset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hows top IPA-predicted canonical pathways represented by the 50 genes common to all the subsets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6ED407FE-8B34-4DC8-B009-3256B64EAD6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7" t="9836" r="4208" b="7541"/>
          <a:stretch/>
        </p:blipFill>
        <p:spPr>
          <a:xfrm>
            <a:off x="6429541" y="1728181"/>
            <a:ext cx="5530721" cy="31917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Arrow: Right 6">
            <a:extLst>
              <a:ext uri="{FF2B5EF4-FFF2-40B4-BE49-F238E27FC236}">
                <a16:creationId xmlns:a16="http://schemas.microsoft.com/office/drawing/2014/main" id="{26DE6315-6E00-42C3-917E-148AB65E1C7F}"/>
              </a:ext>
            </a:extLst>
          </p:cNvPr>
          <p:cNvSpPr/>
          <p:nvPr/>
        </p:nvSpPr>
        <p:spPr>
          <a:xfrm>
            <a:off x="3740043" y="3429000"/>
            <a:ext cx="3155431" cy="318541"/>
          </a:xfrm>
          <a:prstGeom prst="rightArrow">
            <a:avLst/>
          </a:prstGeom>
          <a:gradFill flip="none" rotWithShape="1">
            <a:gsLst>
              <a:gs pos="0">
                <a:schemeClr val="accent2">
                  <a:lumMod val="67000"/>
                </a:schemeClr>
              </a:gs>
              <a:gs pos="48000">
                <a:schemeClr val="accent2">
                  <a:lumMod val="97000"/>
                  <a:lumOff val="3000"/>
                </a:schemeClr>
              </a:gs>
              <a:gs pos="100000">
                <a:schemeClr val="accent2">
                  <a:lumMod val="60000"/>
                  <a:lumOff val="40000"/>
                </a:schemeClr>
              </a:gs>
            </a:gsLst>
            <a:lin ang="16200000" scaled="1"/>
            <a:tileRect/>
          </a:gra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10474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276829C-C766-4264-BD8E-03683E219E6F}"/>
              </a:ext>
            </a:extLst>
          </p:cNvPr>
          <p:cNvSpPr txBox="1"/>
          <p:nvPr/>
        </p:nvSpPr>
        <p:spPr>
          <a:xfrm>
            <a:off x="0" y="0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8: </a:t>
            </a:r>
            <a:r>
              <a:rPr lang="en-US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PA predicted upregulation of the microRNA let-7 as the top upstream regulator based on significantly differentially expressed genes following 17AAG+Ixa combination treatment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Chart, radar chart&#10;&#10;Description automatically generated">
            <a:extLst>
              <a:ext uri="{FF2B5EF4-FFF2-40B4-BE49-F238E27FC236}">
                <a16:creationId xmlns:a16="http://schemas.microsoft.com/office/drawing/2014/main" id="{E8068912-4BAF-46AF-AA71-D25A83226D5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2" b="2964"/>
          <a:stretch/>
        </p:blipFill>
        <p:spPr>
          <a:xfrm>
            <a:off x="3154934" y="748146"/>
            <a:ext cx="6321575" cy="6061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2754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C06D7D6-7D9D-4A86-99FC-D3EB99C985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0892623"/>
              </p:ext>
            </p:extLst>
          </p:nvPr>
        </p:nvGraphicFramePr>
        <p:xfrm>
          <a:off x="8124000" y="1383404"/>
          <a:ext cx="3770872" cy="19685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9" name="Prism 8" r:id="rId3" imgW="5833059" imgH="3044555" progId="Prism8.Document">
                  <p:embed/>
                </p:oleObj>
              </mc:Choice>
              <mc:Fallback>
                <p:oleObj name="Prism 8" r:id="rId3" imgW="5833059" imgH="3044555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8C06D7D6-7D9D-4A86-99FC-D3EB99C985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124000" y="1383404"/>
                        <a:ext cx="3770872" cy="196857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F2028EE4-B249-496B-948C-ECE90C05A8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1223" y="3416475"/>
            <a:ext cx="3770872" cy="1967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F70E232-7E1A-4B03-9420-39B6C178D2F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7775" y="3416475"/>
            <a:ext cx="3818153" cy="19933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99DBA58-D646-4D07-BC1E-65DF3F62CE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39979" y="1386640"/>
            <a:ext cx="3767694" cy="19659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EE35418-149F-483C-ABC9-75E260CAD5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39979" y="3442187"/>
            <a:ext cx="3770872" cy="1967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3BD90F5-F824-442C-B90A-C721399912B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7775" y="1384982"/>
            <a:ext cx="3767694" cy="19669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8EAF61B-AC96-43F2-95EB-64430B5D446D}"/>
              </a:ext>
            </a:extLst>
          </p:cNvPr>
          <p:cNvSpPr txBox="1"/>
          <p:nvPr/>
        </p:nvSpPr>
        <p:spPr>
          <a:xfrm>
            <a:off x="2811651" y="4182310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81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6.8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9C666C-08E5-4D64-B4EE-AA05E4DCB211}"/>
              </a:ext>
            </a:extLst>
          </p:cNvPr>
          <p:cNvSpPr txBox="1"/>
          <p:nvPr/>
        </p:nvSpPr>
        <p:spPr>
          <a:xfrm>
            <a:off x="6746131" y="2214358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968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9.6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74615E-3BC8-4298-B4A0-E97C4E972248}"/>
              </a:ext>
            </a:extLst>
          </p:cNvPr>
          <p:cNvSpPr txBox="1"/>
          <p:nvPr/>
        </p:nvSpPr>
        <p:spPr>
          <a:xfrm>
            <a:off x="2832967" y="2214358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697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8.8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10CA26-3FEA-453D-9B71-4D52BC36C6EB}"/>
              </a:ext>
            </a:extLst>
          </p:cNvPr>
          <p:cNvSpPr txBox="1"/>
          <p:nvPr/>
        </p:nvSpPr>
        <p:spPr>
          <a:xfrm>
            <a:off x="10633330" y="2133322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204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9.1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C16B29-F778-45E1-A8DF-4F744FFB7F3E}"/>
              </a:ext>
            </a:extLst>
          </p:cNvPr>
          <p:cNvSpPr txBox="1"/>
          <p:nvPr/>
        </p:nvSpPr>
        <p:spPr>
          <a:xfrm>
            <a:off x="10517003" y="4182310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449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4.7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A9F39E-3740-40EA-96E8-CDCEDA3E80BE}"/>
              </a:ext>
            </a:extLst>
          </p:cNvPr>
          <p:cNvSpPr txBox="1"/>
          <p:nvPr/>
        </p:nvSpPr>
        <p:spPr>
          <a:xfrm>
            <a:off x="6789723" y="4271563"/>
            <a:ext cx="1334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I: 0.892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RI: 4.3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050C0E-A743-4895-936B-04CF78EB0A9F}"/>
              </a:ext>
            </a:extLst>
          </p:cNvPr>
          <p:cNvSpPr txBox="1"/>
          <p:nvPr/>
        </p:nvSpPr>
        <p:spPr>
          <a:xfrm>
            <a:off x="21272" y="41117"/>
            <a:ext cx="61038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3185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CFE4816-C981-48BE-B47D-C820E3ADB2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9336" y="719528"/>
            <a:ext cx="3946045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1C9339-119A-40AE-AE9B-BF165254E4C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108974" y="719528"/>
          <a:ext cx="3955379" cy="19264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9" r:id="rId4" imgW="6127142" imgH="2983722" progId="Prism9.Document">
                  <p:embed/>
                </p:oleObj>
              </mc:Choice>
              <mc:Fallback>
                <p:oleObj name="Prism 9" r:id="rId4" imgW="6127142" imgH="298372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1C9339-119A-40AE-AE9B-BF165254E4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08974" y="719528"/>
                        <a:ext cx="3955379" cy="192645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FEDBA33D-45A0-4706-B278-6303FAE6E2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36621" y="719528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3E4EE46-48E3-4ADE-B53B-4C5979DFC7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-9335" y="2889681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3D430C7-D0B5-4505-8AD9-086B948DA1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08975" y="2889681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A88C874-DCBE-41C7-A2E9-885BC1059E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27285" y="2889681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5DF7AD9-AD76-4186-8655-F4FEBE37B48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74348" y="4931546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2D342A0-8F67-40FC-AB84-C6BE6BDF51A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406823" y="4931546"/>
            <a:ext cx="3946044" cy="19264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FF50B7A-6FB0-4214-B59F-59BBBF741C84}"/>
              </a:ext>
            </a:extLst>
          </p:cNvPr>
          <p:cNvSpPr txBox="1"/>
          <p:nvPr/>
        </p:nvSpPr>
        <p:spPr>
          <a:xfrm>
            <a:off x="2797721" y="168275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96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2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857136-6623-495F-AA19-A11170BC4440}"/>
              </a:ext>
            </a:extLst>
          </p:cNvPr>
          <p:cNvSpPr txBox="1"/>
          <p:nvPr/>
        </p:nvSpPr>
        <p:spPr>
          <a:xfrm>
            <a:off x="6925368" y="168275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1.46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8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F99A141-04EA-485E-B707-6279D0A41A92}"/>
              </a:ext>
            </a:extLst>
          </p:cNvPr>
          <p:cNvSpPr txBox="1"/>
          <p:nvPr/>
        </p:nvSpPr>
        <p:spPr>
          <a:xfrm>
            <a:off x="11050207" y="168275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8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4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ED9FF7-12D0-4C76-B9DE-D7F0F3968B03}"/>
              </a:ext>
            </a:extLst>
          </p:cNvPr>
          <p:cNvSpPr txBox="1"/>
          <p:nvPr/>
        </p:nvSpPr>
        <p:spPr>
          <a:xfrm>
            <a:off x="2797722" y="3883980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8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3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39578C0-092B-4882-BBEE-FC98D13FF912}"/>
              </a:ext>
            </a:extLst>
          </p:cNvPr>
          <p:cNvSpPr txBox="1"/>
          <p:nvPr/>
        </p:nvSpPr>
        <p:spPr>
          <a:xfrm>
            <a:off x="6916033" y="3883980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47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9.7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7BA6E7F-1FA2-4DB8-8107-BA04B6B7C730}"/>
              </a:ext>
            </a:extLst>
          </p:cNvPr>
          <p:cNvSpPr txBox="1"/>
          <p:nvPr/>
        </p:nvSpPr>
        <p:spPr>
          <a:xfrm>
            <a:off x="11050208" y="3883980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69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6.2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19E1812-AF07-4A7A-B854-F8EA2AB51033}"/>
              </a:ext>
            </a:extLst>
          </p:cNvPr>
          <p:cNvSpPr txBox="1"/>
          <p:nvPr/>
        </p:nvSpPr>
        <p:spPr>
          <a:xfrm>
            <a:off x="5123069" y="589477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79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9.1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ABA370-92F4-4127-BC35-0409EA410A39}"/>
              </a:ext>
            </a:extLst>
          </p:cNvPr>
          <p:cNvSpPr txBox="1"/>
          <p:nvPr/>
        </p:nvSpPr>
        <p:spPr>
          <a:xfrm>
            <a:off x="9402232" y="5894773"/>
            <a:ext cx="8603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45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10.8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8B4CE1E-FB3A-42E7-B777-CF8F78113CA7}"/>
              </a:ext>
            </a:extLst>
          </p:cNvPr>
          <p:cNvSpPr txBox="1"/>
          <p:nvPr/>
        </p:nvSpPr>
        <p:spPr>
          <a:xfrm>
            <a:off x="-21857" y="53249"/>
            <a:ext cx="61038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0225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38C3682-B393-449A-ACD0-3AAD9F4C61C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0" y="857840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0" name="Prism 9" r:id="rId3" imgW="5974881" imgH="2983722" progId="Prism9.Document">
                  <p:embed/>
                </p:oleObj>
              </mc:Choice>
              <mc:Fallback>
                <p:oleObj name="Prism 9" r:id="rId3" imgW="5974881" imgH="298372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38C3682-B393-449A-ACD0-3AAD9F4C61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857840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76800D6-B1E7-4C6B-BE05-BCEE41E1AE5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58892" y="857840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1" name="Prism 9" r:id="rId5" imgW="5974881" imgH="2983722" progId="Prism9.Document">
                  <p:embed/>
                </p:oleObj>
              </mc:Choice>
              <mc:Fallback>
                <p:oleObj name="Prism 9" r:id="rId5" imgW="5974881" imgH="2983722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76800D6-B1E7-4C6B-BE05-BCEE41E1AE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58892" y="857840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6981A30-71B9-4E35-983D-C73F8927BC9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420453" y="857840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2" name="Prism 9" r:id="rId7" imgW="5974881" imgH="2983722" progId="Prism9.Document">
                  <p:embed/>
                </p:oleObj>
              </mc:Choice>
              <mc:Fallback>
                <p:oleObj name="Prism 9" r:id="rId7" imgW="5974881" imgH="298372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6981A30-71B9-4E35-983D-C73F8927BC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420453" y="857840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D34F455-CBC0-4715-BF1C-8A6F65443FD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97332" y="3037873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3" name="Prism 9" r:id="rId9" imgW="5974881" imgH="2983722" progId="Prism9.Document">
                  <p:embed/>
                </p:oleObj>
              </mc:Choice>
              <mc:Fallback>
                <p:oleObj name="Prism 9" r:id="rId9" imgW="5974881" imgH="2983722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D34F455-CBC0-4715-BF1C-8A6F65443F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7332" y="3037873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E80DD13-D05E-4490-8A54-0B2B3D11927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91255" y="3028490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4" name="Prism 9" r:id="rId11" imgW="5974881" imgH="2983722" progId="Prism9.Document">
                  <p:embed/>
                </p:oleObj>
              </mc:Choice>
              <mc:Fallback>
                <p:oleObj name="Prism 9" r:id="rId11" imgW="5974881" imgH="2983722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E80DD13-D05E-4490-8A54-0B2B3D1192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91255" y="3028490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5C0A73A-460B-4709-8E7A-D1E1407B081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420453" y="3028489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5" name="Prism 9" r:id="rId13" imgW="5974881" imgH="2983722" progId="Prism9.Document">
                  <p:embed/>
                </p:oleObj>
              </mc:Choice>
              <mc:Fallback>
                <p:oleObj name="Prism 9" r:id="rId13" imgW="5974881" imgH="2983722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85C0A73A-460B-4709-8E7A-D1E1407B08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420453" y="3028489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C1774258-B1D5-4972-B8B8-315E6EEBB9E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25756" y="4955358"/>
            <a:ext cx="3665640" cy="183515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9562F49-5DC0-465D-8513-856E66A49D1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19696" y="4959258"/>
          <a:ext cx="3674215" cy="1835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56" name="Prism 9" r:id="rId16" imgW="5974881" imgH="2983722" progId="Prism9.Document">
                  <p:embed/>
                </p:oleObj>
              </mc:Choice>
              <mc:Fallback>
                <p:oleObj name="Prism 9" r:id="rId16" imgW="5974881" imgH="2983722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79562F49-5DC0-465D-8513-856E66A49D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419696" y="4959258"/>
                        <a:ext cx="3674215" cy="183515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F953D954-1E3E-41D4-82E1-229CFD2B580B}"/>
              </a:ext>
            </a:extLst>
          </p:cNvPr>
          <p:cNvSpPr txBox="1"/>
          <p:nvPr/>
        </p:nvSpPr>
        <p:spPr>
          <a:xfrm>
            <a:off x="2625756" y="1775417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28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6.3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CA24AC-6A43-40D6-91F8-ED379A977DD8}"/>
              </a:ext>
            </a:extLst>
          </p:cNvPr>
          <p:cNvSpPr txBox="1"/>
          <p:nvPr/>
        </p:nvSpPr>
        <p:spPr>
          <a:xfrm>
            <a:off x="6923744" y="1775417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67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1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835CB9-C368-4118-AE58-9E2F0FA1E61D}"/>
              </a:ext>
            </a:extLst>
          </p:cNvPr>
          <p:cNvSpPr txBox="1"/>
          <p:nvPr/>
        </p:nvSpPr>
        <p:spPr>
          <a:xfrm>
            <a:off x="11087372" y="1775417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79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2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63AE430-5D27-40B8-AB34-A49A96C2080C}"/>
              </a:ext>
            </a:extLst>
          </p:cNvPr>
          <p:cNvSpPr txBox="1"/>
          <p:nvPr/>
        </p:nvSpPr>
        <p:spPr>
          <a:xfrm>
            <a:off x="6958417" y="408678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7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9.5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6EA47D-2D5F-4F90-9316-426B08D92AB4}"/>
              </a:ext>
            </a:extLst>
          </p:cNvPr>
          <p:cNvSpPr txBox="1"/>
          <p:nvPr/>
        </p:nvSpPr>
        <p:spPr>
          <a:xfrm>
            <a:off x="2625756" y="408678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8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4.3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52AFC8-7334-4AA0-B9B1-1312426000CF}"/>
              </a:ext>
            </a:extLst>
          </p:cNvPr>
          <p:cNvSpPr txBox="1"/>
          <p:nvPr/>
        </p:nvSpPr>
        <p:spPr>
          <a:xfrm>
            <a:off x="11087372" y="408678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3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1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3784958-4599-4741-A8F2-895A9AF40BB8}"/>
              </a:ext>
            </a:extLst>
          </p:cNvPr>
          <p:cNvSpPr txBox="1"/>
          <p:nvPr/>
        </p:nvSpPr>
        <p:spPr>
          <a:xfrm>
            <a:off x="5279252" y="5956732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86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9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7FE212-CE65-4B1D-B36F-BFE5EABF5EF9}"/>
              </a:ext>
            </a:extLst>
          </p:cNvPr>
          <p:cNvSpPr txBox="1"/>
          <p:nvPr/>
        </p:nvSpPr>
        <p:spPr>
          <a:xfrm>
            <a:off x="9241518" y="5893636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700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9.9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91A1465-BA1C-4BA5-9B0A-1B14A4AD0A26}"/>
              </a:ext>
            </a:extLst>
          </p:cNvPr>
          <p:cNvSpPr txBox="1"/>
          <p:nvPr/>
        </p:nvSpPr>
        <p:spPr>
          <a:xfrm>
            <a:off x="187542" y="131826"/>
            <a:ext cx="61038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9662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9A5783C-83E6-4123-9ACC-CF468BE1E77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8261" y="505857"/>
          <a:ext cx="3581943" cy="17577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6" name="Prism 9" r:id="rId3" imgW="6081428" imgH="2983722" progId="Prism9.Document">
                  <p:embed/>
                </p:oleObj>
              </mc:Choice>
              <mc:Fallback>
                <p:oleObj name="Prism 9" r:id="rId3" imgW="6081428" imgH="298372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9A5783C-83E6-4123-9ACC-CF468BE1E7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261" y="505857"/>
                        <a:ext cx="3581943" cy="175777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39C820E-7783-4913-A03A-CB5D4D28BA0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120661" y="505858"/>
          <a:ext cx="3581940" cy="1757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7" name="Prism 9" r:id="rId5" imgW="6081428" imgH="2983722" progId="Prism9.Document">
                  <p:embed/>
                </p:oleObj>
              </mc:Choice>
              <mc:Fallback>
                <p:oleObj name="Prism 9" r:id="rId5" imgW="6081428" imgH="2983722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39C820E-7783-4913-A03A-CB5D4D28BA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20661" y="505858"/>
                        <a:ext cx="3581940" cy="175777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601A5690-4952-4056-A0D6-DD305983E6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87862" y="505858"/>
            <a:ext cx="3581942" cy="17618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934F8D8-FD23-4D34-B21E-7F138BD839D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8261" y="2463076"/>
            <a:ext cx="3573701" cy="17577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0BA2328-2389-4EB7-A300-3093E2E4D22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20658" y="2463076"/>
            <a:ext cx="3573701" cy="1757778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C875940-AA11-4D8A-A342-3891170ABE4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379620" y="2351158"/>
          <a:ext cx="3581940" cy="1757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8" name="Prism 9" r:id="rId10" imgW="6081428" imgH="2983722" progId="Prism9.Document">
                  <p:embed/>
                </p:oleObj>
              </mc:Choice>
              <mc:Fallback>
                <p:oleObj name="Prism 9" r:id="rId10" imgW="6081428" imgH="2983722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C875940-AA11-4D8A-A342-3891170ABE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379620" y="2351158"/>
                        <a:ext cx="3581940" cy="175777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242C159-830E-4607-8A5E-882D8EA1C800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364308" y="4548884"/>
          <a:ext cx="3581940" cy="1757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9" name="Prism 9" r:id="rId12" imgW="6081428" imgH="2983722" progId="Prism9.Document">
                  <p:embed/>
                </p:oleObj>
              </mc:Choice>
              <mc:Fallback>
                <p:oleObj name="Prism 9" r:id="rId12" imgW="6081428" imgH="2983722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0242C159-830E-4607-8A5E-882D8EA1C8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364308" y="4548884"/>
                        <a:ext cx="3581940" cy="175777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C79342A-4743-4792-A61A-8F4EFABC131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79340" y="4548884"/>
          <a:ext cx="3573702" cy="17537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0" name="Prism 9" r:id="rId14" imgW="6081428" imgH="2983722" progId="Prism9.Document">
                  <p:embed/>
                </p:oleObj>
              </mc:Choice>
              <mc:Fallback>
                <p:oleObj name="Prism 9" r:id="rId14" imgW="6081428" imgH="2983722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C79342A-4743-4792-A61A-8F4EFABC13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479340" y="4548884"/>
                        <a:ext cx="3573702" cy="175373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E8DC58C-E9C9-4F2F-A5CA-5C0A83019062}"/>
              </a:ext>
            </a:extLst>
          </p:cNvPr>
          <p:cNvSpPr txBox="1"/>
          <p:nvPr/>
        </p:nvSpPr>
        <p:spPr>
          <a:xfrm>
            <a:off x="2705314" y="145570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805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9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7B0B02-2140-461B-9C1A-6D4DAF93886A}"/>
              </a:ext>
            </a:extLst>
          </p:cNvPr>
          <p:cNvSpPr txBox="1"/>
          <p:nvPr/>
        </p:nvSpPr>
        <p:spPr>
          <a:xfrm>
            <a:off x="6820113" y="145570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356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9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A699E0F-B1E6-4965-9041-4A3E9E01FB6E}"/>
              </a:ext>
            </a:extLst>
          </p:cNvPr>
          <p:cNvSpPr txBox="1"/>
          <p:nvPr/>
        </p:nvSpPr>
        <p:spPr>
          <a:xfrm>
            <a:off x="11153056" y="145570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9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2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BB67A35-EECA-4E39-B460-10E448B24D2D}"/>
              </a:ext>
            </a:extLst>
          </p:cNvPr>
          <p:cNvSpPr txBox="1"/>
          <p:nvPr/>
        </p:nvSpPr>
        <p:spPr>
          <a:xfrm>
            <a:off x="2697072" y="341658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1.006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8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7DDF7F-449E-49C2-93A8-9C35A982F396}"/>
              </a:ext>
            </a:extLst>
          </p:cNvPr>
          <p:cNvSpPr txBox="1"/>
          <p:nvPr/>
        </p:nvSpPr>
        <p:spPr>
          <a:xfrm>
            <a:off x="6877613" y="341658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59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6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F480DD8-AE6D-4367-88BD-2121F2AE4C0D}"/>
              </a:ext>
            </a:extLst>
          </p:cNvPr>
          <p:cNvSpPr txBox="1"/>
          <p:nvPr/>
        </p:nvSpPr>
        <p:spPr>
          <a:xfrm>
            <a:off x="11144814" y="341658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29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5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E01719B-2319-4FC7-85F0-B421D3647393}"/>
              </a:ext>
            </a:extLst>
          </p:cNvPr>
          <p:cNvSpPr txBox="1"/>
          <p:nvPr/>
        </p:nvSpPr>
        <p:spPr>
          <a:xfrm>
            <a:off x="4987675" y="5425751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1.03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6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CB487BA-D177-4E22-93E1-18BEA0D41388}"/>
              </a:ext>
            </a:extLst>
          </p:cNvPr>
          <p:cNvSpPr txBox="1"/>
          <p:nvPr/>
        </p:nvSpPr>
        <p:spPr>
          <a:xfrm>
            <a:off x="9236296" y="5421378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75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3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635BC19-7264-4ADE-BA5D-31BB5545CCA1}"/>
              </a:ext>
            </a:extLst>
          </p:cNvPr>
          <p:cNvSpPr txBox="1"/>
          <p:nvPr/>
        </p:nvSpPr>
        <p:spPr>
          <a:xfrm>
            <a:off x="0" y="39865"/>
            <a:ext cx="1439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94715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E0AD9B7-1218-4795-844A-9E06C6EFD57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90223" y="336322"/>
          <a:ext cx="4511443" cy="2208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4" name="Prism 9" r:id="rId3" imgW="6096906" imgH="2983722" progId="Prism9.Document">
                  <p:embed/>
                </p:oleObj>
              </mc:Choice>
              <mc:Fallback>
                <p:oleObj name="Prism 9" r:id="rId3" imgW="6096906" imgH="298372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E0AD9B7-1218-4795-844A-9E06C6EFD5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90223" y="336322"/>
                        <a:ext cx="4511443" cy="220815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2A74A14-73E1-4588-BD51-3DECF28707B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46930" y="348225"/>
          <a:ext cx="4634770" cy="2208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5" name="Prism 9" r:id="rId5" imgW="6264284" imgH="2983722" progId="Prism9.Document">
                  <p:embed/>
                </p:oleObj>
              </mc:Choice>
              <mc:Fallback>
                <p:oleObj name="Prism 9" r:id="rId5" imgW="6264284" imgH="2983722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2A74A14-73E1-4588-BD51-3DECF28707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46930" y="348225"/>
                        <a:ext cx="4634770" cy="220815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FFB076D-F653-4612-9BEC-58BCC1BE8DB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573823" y="2491930"/>
          <a:ext cx="4511442" cy="2208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6" name="Prism 9" r:id="rId7" imgW="6096906" imgH="2983722" progId="Prism9.Document">
                  <p:embed/>
                </p:oleObj>
              </mc:Choice>
              <mc:Fallback>
                <p:oleObj name="Prism 9" r:id="rId7" imgW="6096906" imgH="298372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FFB076D-F653-4612-9BEC-58BCC1BE8D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73823" y="2491930"/>
                        <a:ext cx="4511442" cy="220815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06F3F9B-508F-4A7F-B9BD-96886F5CBE6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46930" y="2491930"/>
          <a:ext cx="4511442" cy="2208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7" name="Prism 9" r:id="rId9" imgW="6096906" imgH="2983722" progId="Prism9.Document">
                  <p:embed/>
                </p:oleObj>
              </mc:Choice>
              <mc:Fallback>
                <p:oleObj name="Prism 9" r:id="rId9" imgW="6096906" imgH="2983722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06F3F9B-508F-4A7F-B9BD-96886F5CBE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46930" y="2491930"/>
                        <a:ext cx="4511442" cy="220815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822FB48-9A2E-4C55-A75C-902E6B28436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7992" y="4816635"/>
          <a:ext cx="4000081" cy="1957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8" name="Prism 9" r:id="rId11" imgW="6096906" imgH="2983722" progId="Prism9.Document">
                  <p:embed/>
                </p:oleObj>
              </mc:Choice>
              <mc:Fallback>
                <p:oleObj name="Prism 9" r:id="rId11" imgW="6096906" imgH="2983722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822FB48-9A2E-4C55-A75C-902E6B2843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7992" y="4816635"/>
                        <a:ext cx="4000081" cy="195786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1D94234E-0B09-4147-A753-8BEF2CD021F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12710" y="4797698"/>
            <a:ext cx="4000081" cy="1962587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01F6960-9F61-4018-A037-638274FEE0A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156751" y="4799905"/>
          <a:ext cx="4000081" cy="1957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9" name="Prism 9" r:id="rId14" imgW="6096906" imgH="2983722" progId="Prism9.Document">
                  <p:embed/>
                </p:oleObj>
              </mc:Choice>
              <mc:Fallback>
                <p:oleObj name="Prism 9" r:id="rId14" imgW="6096906" imgH="2983722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401F6960-9F61-4018-A037-638274FEE0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156751" y="4799905"/>
                        <a:ext cx="4000081" cy="195786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BBB073BF-CFC6-4376-991A-061A5BE2E9D8}"/>
              </a:ext>
            </a:extLst>
          </p:cNvPr>
          <p:cNvSpPr txBox="1"/>
          <p:nvPr/>
        </p:nvSpPr>
        <p:spPr>
          <a:xfrm>
            <a:off x="3635527" y="852136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4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1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7D7D3D-4EF3-47EE-A307-B7FAA09BAC60}"/>
              </a:ext>
            </a:extLst>
          </p:cNvPr>
          <p:cNvSpPr txBox="1"/>
          <p:nvPr/>
        </p:nvSpPr>
        <p:spPr>
          <a:xfrm>
            <a:off x="8311495" y="852136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22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6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12539B-BAB1-481E-9CD8-CD29CAADCF18}"/>
              </a:ext>
            </a:extLst>
          </p:cNvPr>
          <p:cNvSpPr txBox="1"/>
          <p:nvPr/>
        </p:nvSpPr>
        <p:spPr>
          <a:xfrm>
            <a:off x="4565598" y="3712778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07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4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97776B-3D2F-444B-9A68-1F573ED0F7A6}"/>
              </a:ext>
            </a:extLst>
          </p:cNvPr>
          <p:cNvSpPr txBox="1"/>
          <p:nvPr/>
        </p:nvSpPr>
        <p:spPr>
          <a:xfrm>
            <a:off x="9236625" y="3712778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76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9.7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29ECB0-7B7A-477B-9B29-96D9E793B8A6}"/>
              </a:ext>
            </a:extLst>
          </p:cNvPr>
          <p:cNvSpPr txBox="1"/>
          <p:nvPr/>
        </p:nvSpPr>
        <p:spPr>
          <a:xfrm>
            <a:off x="2704146" y="590358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1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7.1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C8A61DA-169F-4546-9853-10DAAA222DFF}"/>
              </a:ext>
            </a:extLst>
          </p:cNvPr>
          <p:cNvSpPr txBox="1"/>
          <p:nvPr/>
        </p:nvSpPr>
        <p:spPr>
          <a:xfrm>
            <a:off x="6878821" y="5879068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86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7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55E6489-35A9-4506-BF80-7DABCB520F16}"/>
              </a:ext>
            </a:extLst>
          </p:cNvPr>
          <p:cNvSpPr txBox="1"/>
          <p:nvPr/>
        </p:nvSpPr>
        <p:spPr>
          <a:xfrm>
            <a:off x="10969257" y="5903585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1.113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7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635BC19-7264-4ADE-BA5D-31BB5545CCA1}"/>
              </a:ext>
            </a:extLst>
          </p:cNvPr>
          <p:cNvSpPr txBox="1"/>
          <p:nvPr/>
        </p:nvSpPr>
        <p:spPr>
          <a:xfrm>
            <a:off x="105879" y="28778"/>
            <a:ext cx="1439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98722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ADBE363-025C-4D65-B525-F38BA6F9A6F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821145" y="24140"/>
          <a:ext cx="4418744" cy="2162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2" name="Prism 9" r:id="rId3" imgW="6096906" imgH="2983722" progId="Prism9.Document">
                  <p:embed/>
                </p:oleObj>
              </mc:Choice>
              <mc:Fallback>
                <p:oleObj name="Prism 9" r:id="rId3" imgW="6096906" imgH="2983722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ADBE363-025C-4D65-B525-F38BA6F9A6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21145" y="24140"/>
                        <a:ext cx="4418744" cy="216278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C65C7732-12BA-43F6-B7A5-C6205A7374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50467" y="2237872"/>
            <a:ext cx="4547519" cy="21715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AF82C20-B4CA-4253-B979-9533AFD654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50468" y="4562956"/>
            <a:ext cx="4547519" cy="223118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8306B39-5B6A-459A-8B86-CD0BC65A38F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70472" y="4562956"/>
          <a:ext cx="4668282" cy="22241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3" name="Prism 9" r:id="rId7" imgW="6264284" imgH="2983722" progId="Prism9.Document">
                  <p:embed/>
                </p:oleObj>
              </mc:Choice>
              <mc:Fallback>
                <p:oleObj name="Prism 9" r:id="rId7" imgW="6264284" imgH="2983722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8306B39-5B6A-459A-8B86-CD0BC65A38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470472" y="4562956"/>
                        <a:ext cx="4668282" cy="2224118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7D0D05F1-8344-4E08-9EBF-8354CD2D422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470473" y="2262544"/>
            <a:ext cx="4636112" cy="22241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0276006-B6A7-4715-B4C1-6D483C980173}"/>
              </a:ext>
            </a:extLst>
          </p:cNvPr>
          <p:cNvSpPr txBox="1"/>
          <p:nvPr/>
        </p:nvSpPr>
        <p:spPr>
          <a:xfrm>
            <a:off x="7146596" y="1331851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54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4.3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51FA37-8B4A-4F24-A84F-2ADE5B4E6D7D}"/>
              </a:ext>
            </a:extLst>
          </p:cNvPr>
          <p:cNvSpPr txBox="1"/>
          <p:nvPr/>
        </p:nvSpPr>
        <p:spPr>
          <a:xfrm>
            <a:off x="5381241" y="3371453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625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8.8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CFBF39B-D424-4650-A88C-E25180AD6278}"/>
              </a:ext>
            </a:extLst>
          </p:cNvPr>
          <p:cNvSpPr txBox="1"/>
          <p:nvPr/>
        </p:nvSpPr>
        <p:spPr>
          <a:xfrm>
            <a:off x="10061735" y="3537384"/>
            <a:ext cx="816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1.35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5.5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6C2860-DB0F-4EAB-AC92-7332B8BCEAF7}"/>
              </a:ext>
            </a:extLst>
          </p:cNvPr>
          <p:cNvSpPr txBox="1"/>
          <p:nvPr/>
        </p:nvSpPr>
        <p:spPr>
          <a:xfrm>
            <a:off x="5135399" y="5759095"/>
            <a:ext cx="8951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190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10.9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F71B01-9A37-411C-8E8D-343DE17A0B8B}"/>
              </a:ext>
            </a:extLst>
          </p:cNvPr>
          <p:cNvSpPr txBox="1"/>
          <p:nvPr/>
        </p:nvSpPr>
        <p:spPr>
          <a:xfrm>
            <a:off x="10308688" y="5712781"/>
            <a:ext cx="9393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= 0.220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RI= 10.5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35BC19-7264-4ADE-BA5D-31BB5545CCA1}"/>
              </a:ext>
            </a:extLst>
          </p:cNvPr>
          <p:cNvSpPr txBox="1"/>
          <p:nvPr/>
        </p:nvSpPr>
        <p:spPr>
          <a:xfrm>
            <a:off x="105879" y="28778"/>
            <a:ext cx="14390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IN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1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88645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36CD7E7-FEAA-4C25-B77E-A97BC2B3684B}"/>
              </a:ext>
            </a:extLst>
          </p:cNvPr>
          <p:cNvSpPr txBox="1"/>
          <p:nvPr/>
        </p:nvSpPr>
        <p:spPr>
          <a:xfrm>
            <a:off x="0" y="14891"/>
            <a:ext cx="12192000" cy="9814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800" b="1" dirty="0" smtClean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: 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dicted decrease in IC</a:t>
            </a:r>
            <a:r>
              <a:rPr lang="en-US" sz="1800" b="1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M concentration) in 17-AAG+PI combination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ose reduction index (DRI) values demonstrated that 17-AAG improved the therapeutic index of PI an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i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dministration to the cells and decreased the amount of PI/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iD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quired to achieve respon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3F9279-0D19-477B-B250-6A0866FAC6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9246" y="3920683"/>
            <a:ext cx="1897266" cy="27619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4485249-0366-4A44-A58E-6C3E4975D3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2981" y="3948548"/>
            <a:ext cx="1897266" cy="27341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DC67DC5-0201-4F54-8320-12146BB79C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61773" y="3920682"/>
            <a:ext cx="1968918" cy="27459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60927A0-B156-4D5A-ADDB-F230DA1E64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55510" y="3920682"/>
            <a:ext cx="1897265" cy="2734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D7B3287-2503-4897-86B5-AA82AB66CF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51114" y="1085307"/>
            <a:ext cx="1897266" cy="27341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F1302A4-3F6D-4371-8027-021A63DDF0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29995" y="1084999"/>
            <a:ext cx="1897267" cy="27341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3E83411-03AC-473D-9CBE-5EA3FACE00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67244" y="1109425"/>
            <a:ext cx="1902255" cy="27341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50" name="Picture 2">
            <a:extLst>
              <a:ext uri="{FF2B5EF4-FFF2-40B4-BE49-F238E27FC236}">
                <a16:creationId xmlns:a16="http://schemas.microsoft.com/office/drawing/2014/main" id="{E5A74048-23D7-4897-AB32-13C1223051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1029" y="1085463"/>
            <a:ext cx="1834600" cy="27577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>
            <a:extLst>
              <a:ext uri="{FF2B5EF4-FFF2-40B4-BE49-F238E27FC236}">
                <a16:creationId xmlns:a16="http://schemas.microsoft.com/office/drawing/2014/main" id="{0CBA3529-41A8-45C5-BC76-391346E21F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4280" y="1097290"/>
            <a:ext cx="1848013" cy="273412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49408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088EE2DC-4C91-497D-BE29-80B787AC96D6}"/>
              </a:ext>
            </a:extLst>
          </p:cNvPr>
          <p:cNvSpPr txBox="1"/>
          <p:nvPr/>
        </p:nvSpPr>
        <p:spPr>
          <a:xfrm>
            <a:off x="77772" y="0"/>
            <a:ext cx="12114228" cy="23237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800" b="1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.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ting analysis </a:t>
            </a:r>
            <a:r>
              <a:rPr lang="en-US" sz="1800" b="1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ults showing 17-AAG treatment-induced changes in protein markers.</a:t>
            </a: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) Representative western blots confirm differential expression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proteins involved in myeloma cell survival and apoptotic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hways in innate sensitive (FLAM76), Innate resistant (LP1) and </a:t>
            </a:r>
            <a:r>
              <a:rPr lang="en-US" dirty="0" smtClean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onally-derived 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quired resistant HMCLs (U266P/VR, RPMI8226P/VR)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) Densitometry analysis. </a:t>
            </a:r>
            <a:r>
              <a:rPr lang="en-US" sz="18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ta-actin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used for normalization of the Western blot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ACFCF3-0173-465F-B7F0-6EFCE4F24B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9318" b="35920"/>
          <a:stretch/>
        </p:blipFill>
        <p:spPr>
          <a:xfrm>
            <a:off x="6868795" y="3316224"/>
            <a:ext cx="404912" cy="2514917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22C7B59-0D8C-4D50-B5AA-CE2D0060409D}"/>
              </a:ext>
            </a:extLst>
          </p:cNvPr>
          <p:cNvSpPr txBox="1"/>
          <p:nvPr/>
        </p:nvSpPr>
        <p:spPr>
          <a:xfrm>
            <a:off x="0" y="2837521"/>
            <a:ext cx="5413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FCFE1FA-88CC-40E7-84AC-710714EB6020}"/>
              </a:ext>
            </a:extLst>
          </p:cNvPr>
          <p:cNvSpPr txBox="1"/>
          <p:nvPr/>
        </p:nvSpPr>
        <p:spPr>
          <a:xfrm>
            <a:off x="7107152" y="2908519"/>
            <a:ext cx="4723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BAD3159-6442-4DDD-BD49-318BE3A4D59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2270"/>
          <a:stretch/>
        </p:blipFill>
        <p:spPr>
          <a:xfrm>
            <a:off x="0" y="3225837"/>
            <a:ext cx="6924853" cy="27496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17A4C88-4A53-4019-91BF-7F4078FFB67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71956" y="3316224"/>
            <a:ext cx="4994670" cy="2659278"/>
          </a:xfrm>
          <a:prstGeom prst="rect">
            <a:avLst/>
          </a:prstGeom>
          <a:ln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2084082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641</Words>
  <Application>Microsoft Office PowerPoint</Application>
  <PresentationFormat>Widescreen</PresentationFormat>
  <Paragraphs>104</Paragraphs>
  <Slides>1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Prism 8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Mitra</dc:creator>
  <cp:lastModifiedBy>Amit Mitra</cp:lastModifiedBy>
  <cp:revision>18</cp:revision>
  <cp:lastPrinted>2021-08-20T00:21:46Z</cp:lastPrinted>
  <dcterms:created xsi:type="dcterms:W3CDTF">2021-07-22T18:51:00Z</dcterms:created>
  <dcterms:modified xsi:type="dcterms:W3CDTF">2022-02-17T05:15:13Z</dcterms:modified>
</cp:coreProperties>
</file>